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65" r:id="rId2"/>
  </p:sldIdLst>
  <p:sldSz cx="6858000" cy="9144000" type="screen4x3"/>
  <p:notesSz cx="9939338" cy="68072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D522B7-1C83-8829-CACA-9FB753ED7AE0}" name="崇史 黒江" initials="崇史" userId="a22cf01eb3c45466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石井源一郎" initials="石井" lastIdx="22" clrIdx="0"/>
  <p:cmAuthor id="7" name="石井 源一郎" initials="石井" lastIdx="43" clrIdx="7"/>
  <p:cmAuthor id="1" name="tomo" initials="t" lastIdx="7" clrIdx="1"/>
  <p:cmAuthor id="8" name="ISHII" initials="I" lastIdx="38" clrIdx="8">
    <p:extLst>
      <p:ext uri="{19B8F6BF-5375-455C-9EA6-DF929625EA0E}">
        <p15:presenceInfo xmlns:p15="http://schemas.microsoft.com/office/powerpoint/2012/main" userId="ISHII" providerId="None"/>
      </p:ext>
    </p:extLst>
  </p:cmAuthor>
  <p:cmAuthor id="2" name="石井源一郎" initials="石井源一郎" lastIdx="5" clrIdx="2"/>
  <p:cmAuthor id="9" name="黒江　崇史" initials="黒江　崇史" lastIdx="1" clrIdx="9">
    <p:extLst>
      <p:ext uri="{19B8F6BF-5375-455C-9EA6-DF929625EA0E}">
        <p15:presenceInfo xmlns:p15="http://schemas.microsoft.com/office/powerpoint/2012/main" userId="S-1-5-21-3587011846-3396554844-2244732206-1001" providerId="AD"/>
      </p:ext>
    </p:extLst>
  </p:cmAuthor>
  <p:cmAuthor id="3" name="ishiiP2292" initials="i" lastIdx="10" clrIdx="3"/>
  <p:cmAuthor id="4" name="TI" initials="T" lastIdx="1" clrIdx="4"/>
  <p:cmAuthor id="5" name="石井　源一郎" initials="石井　源一郎" lastIdx="64" clrIdx="5"/>
  <p:cmAuthor id="6" name="崇史 黒江" initials="崇史" lastIdx="155" clrIdx="6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17" autoAdjust="0"/>
    <p:restoredTop sz="96242" autoAdjust="0"/>
  </p:normalViewPr>
  <p:slideViewPr>
    <p:cSldViewPr>
      <p:cViewPr>
        <p:scale>
          <a:sx n="70" d="100"/>
          <a:sy n="70" d="100"/>
        </p:scale>
        <p:origin x="984" y="-612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994" y="0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/>
          <a:lstStyle>
            <a:lvl1pPr algn="r">
              <a:defRPr sz="1200"/>
            </a:lvl1pPr>
          </a:lstStyle>
          <a:p>
            <a:fld id="{18D96FBF-3B6B-4E7C-B033-A5D0AF30607C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13200" y="509588"/>
            <a:ext cx="1912938" cy="25542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29" tIns="46115" rIns="92229" bIns="4611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5" y="3233422"/>
            <a:ext cx="7951470" cy="3063240"/>
          </a:xfrm>
          <a:prstGeom prst="rect">
            <a:avLst/>
          </a:prstGeom>
        </p:spPr>
        <p:txBody>
          <a:bodyPr vert="horz" lIns="92229" tIns="46115" rIns="92229" bIns="46115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3" y="6465659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994" y="6465659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 anchor="b"/>
          <a:lstStyle>
            <a:lvl1pPr algn="r">
              <a:defRPr sz="1200"/>
            </a:lvl1pPr>
          </a:lstStyle>
          <a:p>
            <a:fld id="{FC1018B4-28F9-43F3-8ACE-503A9AFA7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4094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818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803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533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3796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52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768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813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5837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692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262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067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3CC40-0A3F-488B-8C7F-CE66E8AB49E0}" type="datetimeFigureOut">
              <a:rPr kumimoji="1" lang="ja-JP" altLang="en-US" smtClean="0"/>
              <a:t>2022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2811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6AC780B2-EC25-4C4F-9F64-E38221025F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065761"/>
              </p:ext>
            </p:extLst>
          </p:nvPr>
        </p:nvGraphicFramePr>
        <p:xfrm>
          <a:off x="0" y="1547664"/>
          <a:ext cx="6858001" cy="3152816"/>
        </p:xfrm>
        <a:graphic>
          <a:graphicData uri="http://schemas.openxmlformats.org/drawingml/2006/table">
            <a:tbl>
              <a:tblPr/>
              <a:tblGrid>
                <a:gridCol w="1727881">
                  <a:extLst>
                    <a:ext uri="{9D8B030D-6E8A-4147-A177-3AD203B41FA5}">
                      <a16:colId xmlns:a16="http://schemas.microsoft.com/office/drawing/2014/main" val="817526773"/>
                    </a:ext>
                  </a:extLst>
                </a:gridCol>
                <a:gridCol w="765015">
                  <a:extLst>
                    <a:ext uri="{9D8B030D-6E8A-4147-A177-3AD203B41FA5}">
                      <a16:colId xmlns:a16="http://schemas.microsoft.com/office/drawing/2014/main" val="2949725684"/>
                    </a:ext>
                  </a:extLst>
                </a:gridCol>
                <a:gridCol w="576064">
                  <a:extLst>
                    <a:ext uri="{9D8B030D-6E8A-4147-A177-3AD203B41FA5}">
                      <a16:colId xmlns:a16="http://schemas.microsoft.com/office/drawing/2014/main" val="2585821532"/>
                    </a:ext>
                  </a:extLst>
                </a:gridCol>
                <a:gridCol w="1440160">
                  <a:extLst>
                    <a:ext uri="{9D8B030D-6E8A-4147-A177-3AD203B41FA5}">
                      <a16:colId xmlns:a16="http://schemas.microsoft.com/office/drawing/2014/main" val="2812402359"/>
                    </a:ext>
                  </a:extLst>
                </a:gridCol>
                <a:gridCol w="648072">
                  <a:extLst>
                    <a:ext uri="{9D8B030D-6E8A-4147-A177-3AD203B41FA5}">
                      <a16:colId xmlns:a16="http://schemas.microsoft.com/office/drawing/2014/main" val="737693303"/>
                    </a:ext>
                  </a:extLst>
                </a:gridCol>
                <a:gridCol w="1700809">
                  <a:extLst>
                    <a:ext uri="{9D8B030D-6E8A-4147-A177-3AD203B41FA5}">
                      <a16:colId xmlns:a16="http://schemas.microsoft.com/office/drawing/2014/main" val="916304175"/>
                    </a:ext>
                  </a:extLst>
                </a:gridCol>
              </a:tblGrid>
              <a:tr h="25618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2967375"/>
                  </a:ext>
                </a:extLst>
              </a:tr>
              <a:tr h="2561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ntibody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Clone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Dilution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ntigen retrieval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IHC kit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Source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2581501"/>
                  </a:ext>
                </a:extLst>
              </a:tr>
              <a:tr h="2492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CEACAM8/CD66b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G10F5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:200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6 minutes steaming with CC1 Buffer pH 8.5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ultraView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Novus Biologicals, CO, USA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7271047"/>
                  </a:ext>
                </a:extLst>
              </a:tr>
              <a:tr h="2492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GPX4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EPNCIR144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:200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8 minutes steaming with CC1 Buffer pH 8.5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ultraView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bcam, UK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9273189"/>
                  </a:ext>
                </a:extLst>
              </a:tr>
              <a:tr h="2492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Myeloperoxidase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polyclonal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:600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6 minutes steaming with CC1 Buffer pH 8.5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ultraView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gilent, CA, USA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7817034"/>
                  </a:ext>
                </a:extLst>
              </a:tr>
              <a:tr h="249259">
                <a:tc>
                  <a:txBody>
                    <a:bodyPr/>
                    <a:lstStyle/>
                    <a:p>
                      <a:pPr algn="l" fontAlgn="ctr"/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nti-histone H3 </a:t>
                      </a:r>
                    </a:p>
                    <a:p>
                      <a:pPr algn="l" fontAlgn="ctr"/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(citrulline R2 + R8 + R17)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polyclonal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:300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4 minutes steaming with CC1 Buffer pH 8.5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ultraView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bcam, UK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6035790"/>
                  </a:ext>
                </a:extLst>
              </a:tr>
              <a:tr h="2492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ZEB1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polyclonal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:1000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64 minutes steaming with CC1 Buffer pH 8.5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ultraView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Sigma-Aldrich, UK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0957177"/>
                  </a:ext>
                </a:extLst>
              </a:tr>
              <a:tr h="2492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Cleaved caspase 3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Asp175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:800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6 minutes steaming with CC1 Buffer pH 8.5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ultraView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Cell Signaling Technology, MA, USA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0643167"/>
                  </a:ext>
                </a:extLst>
              </a:tr>
              <a:tr h="2561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Geminin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polyclonal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1:40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32 minutes steaming with CC1 Buffer pH 8.5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OptiView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</a:rPr>
                        <a:t>Protein Tech Inc, IL, USA</a:t>
                      </a: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0925029"/>
                  </a:ext>
                </a:extLst>
              </a:tr>
              <a:tr h="256182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5330" marR="5330" marT="533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5192646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0B21DF1-B088-462C-8C39-AB872538B4AD}"/>
              </a:ext>
            </a:extLst>
          </p:cNvPr>
          <p:cNvSpPr txBox="1"/>
          <p:nvPr/>
        </p:nvSpPr>
        <p:spPr>
          <a:xfrm>
            <a:off x="0" y="1393775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メイリオ" panose="020B0604030504040204" pitchFamily="50" charset="-128"/>
                <a:cs typeface="Helvetica" panose="020B0604020202020204" pitchFamily="34" charset="0"/>
              </a:rPr>
              <a:t>Table S2.</a:t>
            </a:r>
            <a:r>
              <a:rPr kumimoji="1" lang="ja-JP" altLang="en-US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メイリオ" panose="020B0604030504040204" pitchFamily="50" charset="-128"/>
                <a:cs typeface="Helvetica" panose="020B0604020202020204" pitchFamily="34" charset="0"/>
              </a:rPr>
              <a:t> </a:t>
            </a:r>
            <a:r>
              <a:rPr kumimoji="1" lang="en-US" altLang="ja-JP" sz="1400" b="1" i="0" u="none" strike="noStrike" kern="1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ea typeface="メイリオ" panose="020B0604030504040204" pitchFamily="50" charset="-128"/>
                <a:cs typeface="Helvetica" panose="020B0604020202020204" pitchFamily="34" charset="0"/>
              </a:rPr>
              <a:t>Antibodies used in current study</a:t>
            </a:r>
            <a:endParaRPr kumimoji="1" lang="en-US" altLang="ja-JP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HG明朝E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2615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4">
      <a:majorFont>
        <a:latin typeface="Times New Roman"/>
        <a:ea typeface="HGｺﾞｼｯｸM"/>
        <a:cs typeface=""/>
      </a:majorFont>
      <a:minorFont>
        <a:latin typeface="Times New Roman"/>
        <a:ea typeface="HG明朝E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29</TotalTime>
  <Words>147</Words>
  <Application>Microsoft Office PowerPoint</Application>
  <PresentationFormat>画面に合わせる (4:3)</PresentationFormat>
  <Paragraphs>5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</dc:creator>
  <cp:lastModifiedBy>崇史 黒江</cp:lastModifiedBy>
  <cp:revision>597</cp:revision>
  <cp:lastPrinted>2021-05-31T23:33:41Z</cp:lastPrinted>
  <dcterms:created xsi:type="dcterms:W3CDTF">2016-07-10T13:11:22Z</dcterms:created>
  <dcterms:modified xsi:type="dcterms:W3CDTF">2022-09-07T23:56:47Z</dcterms:modified>
</cp:coreProperties>
</file>